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2743200"/>
  <p:notesSz cx="6858000" cy="9144000"/>
  <p:defaultTextStyle>
    <a:defPPr>
      <a:defRPr lang="en-US"/>
    </a:defPPr>
    <a:lvl1pPr marL="0" algn="l" defTabSz="7837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1pPr>
    <a:lvl2pPr marL="391866" algn="l" defTabSz="7837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2pPr>
    <a:lvl3pPr marL="783732" algn="l" defTabSz="7837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3pPr>
    <a:lvl4pPr marL="1175598" algn="l" defTabSz="7837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4pPr>
    <a:lvl5pPr marL="1567464" algn="l" defTabSz="7837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5pPr>
    <a:lvl6pPr marL="1959331" algn="l" defTabSz="7837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6pPr>
    <a:lvl7pPr marL="2351197" algn="l" defTabSz="7837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7pPr>
    <a:lvl8pPr marL="2743063" algn="l" defTabSz="7837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8pPr>
    <a:lvl9pPr marL="3134929" algn="l" defTabSz="783732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98" d="100"/>
          <a:sy n="198" d="100"/>
        </p:scale>
        <p:origin x="-108" y="-690"/>
      </p:cViewPr>
      <p:guideLst>
        <p:guide orient="horz" pos="864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852171"/>
            <a:ext cx="5829300" cy="58801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1554480"/>
            <a:ext cx="4800600" cy="70104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918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837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755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5674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9593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3511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7430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13492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53E27-522A-4E14-B92D-0A123D46A6FB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3E094-9DB4-4FFB-B9CC-07E812699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74328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53E27-522A-4E14-B92D-0A123D46A6FB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3E094-9DB4-4FFB-B9CC-07E812699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33413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58420"/>
            <a:ext cx="1543050" cy="124841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58420"/>
            <a:ext cx="4514850" cy="124841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53E27-522A-4E14-B92D-0A123D46A6FB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3E094-9DB4-4FFB-B9CC-07E812699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85694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53E27-522A-4E14-B92D-0A123D46A6FB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3E094-9DB4-4FFB-B9CC-07E812699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59479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1762760"/>
            <a:ext cx="5829300" cy="544830"/>
          </a:xfrm>
        </p:spPr>
        <p:txBody>
          <a:bodyPr anchor="t"/>
          <a:lstStyle>
            <a:lvl1pPr algn="l">
              <a:defRPr sz="34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1162686"/>
            <a:ext cx="5829300" cy="600075"/>
          </a:xfrm>
        </p:spPr>
        <p:txBody>
          <a:bodyPr anchor="b"/>
          <a:lstStyle>
            <a:lvl1pPr marL="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1pPr>
            <a:lvl2pPr marL="39186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78373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17559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56746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9593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35119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74306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313492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53E27-522A-4E14-B92D-0A123D46A6FB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3E094-9DB4-4FFB-B9CC-07E812699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0912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341631"/>
            <a:ext cx="3028950" cy="96520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341631"/>
            <a:ext cx="3028950" cy="96520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53E27-522A-4E14-B92D-0A123D46A6FB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3E094-9DB4-4FFB-B9CC-07E812699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2968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109856"/>
            <a:ext cx="6172200" cy="4572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614046"/>
            <a:ext cx="3030141" cy="255905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391866" indent="0">
              <a:buNone/>
              <a:defRPr sz="1700" b="1"/>
            </a:lvl2pPr>
            <a:lvl3pPr marL="783732" indent="0">
              <a:buNone/>
              <a:defRPr sz="1500" b="1"/>
            </a:lvl3pPr>
            <a:lvl4pPr marL="1175598" indent="0">
              <a:buNone/>
              <a:defRPr sz="1400" b="1"/>
            </a:lvl4pPr>
            <a:lvl5pPr marL="1567464" indent="0">
              <a:buNone/>
              <a:defRPr sz="1400" b="1"/>
            </a:lvl5pPr>
            <a:lvl6pPr marL="1959331" indent="0">
              <a:buNone/>
              <a:defRPr sz="1400" b="1"/>
            </a:lvl6pPr>
            <a:lvl7pPr marL="2351197" indent="0">
              <a:buNone/>
              <a:defRPr sz="1400" b="1"/>
            </a:lvl7pPr>
            <a:lvl8pPr marL="2743063" indent="0">
              <a:buNone/>
              <a:defRPr sz="1400" b="1"/>
            </a:lvl8pPr>
            <a:lvl9pPr marL="3134929" indent="0">
              <a:buNone/>
              <a:defRPr sz="1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869950"/>
            <a:ext cx="3030141" cy="1580516"/>
          </a:xfrm>
        </p:spPr>
        <p:txBody>
          <a:bodyPr/>
          <a:lstStyle>
            <a:lvl1pPr>
              <a:defRPr sz="2100"/>
            </a:lvl1pPr>
            <a:lvl2pPr>
              <a:defRPr sz="17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614046"/>
            <a:ext cx="3031332" cy="255905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391866" indent="0">
              <a:buNone/>
              <a:defRPr sz="1700" b="1"/>
            </a:lvl2pPr>
            <a:lvl3pPr marL="783732" indent="0">
              <a:buNone/>
              <a:defRPr sz="1500" b="1"/>
            </a:lvl3pPr>
            <a:lvl4pPr marL="1175598" indent="0">
              <a:buNone/>
              <a:defRPr sz="1400" b="1"/>
            </a:lvl4pPr>
            <a:lvl5pPr marL="1567464" indent="0">
              <a:buNone/>
              <a:defRPr sz="1400" b="1"/>
            </a:lvl5pPr>
            <a:lvl6pPr marL="1959331" indent="0">
              <a:buNone/>
              <a:defRPr sz="1400" b="1"/>
            </a:lvl6pPr>
            <a:lvl7pPr marL="2351197" indent="0">
              <a:buNone/>
              <a:defRPr sz="1400" b="1"/>
            </a:lvl7pPr>
            <a:lvl8pPr marL="2743063" indent="0">
              <a:buNone/>
              <a:defRPr sz="1400" b="1"/>
            </a:lvl8pPr>
            <a:lvl9pPr marL="3134929" indent="0">
              <a:buNone/>
              <a:defRPr sz="1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869950"/>
            <a:ext cx="3031332" cy="1580516"/>
          </a:xfrm>
        </p:spPr>
        <p:txBody>
          <a:bodyPr/>
          <a:lstStyle>
            <a:lvl1pPr>
              <a:defRPr sz="2100"/>
            </a:lvl1pPr>
            <a:lvl2pPr>
              <a:defRPr sz="1700"/>
            </a:lvl2pPr>
            <a:lvl3pPr>
              <a:defRPr sz="15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53E27-522A-4E14-B92D-0A123D46A6FB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3E094-9DB4-4FFB-B9CC-07E812699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86837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53E27-522A-4E14-B92D-0A123D46A6FB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3E094-9DB4-4FFB-B9CC-07E812699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92771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53E27-522A-4E14-B92D-0A123D46A6FB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3E094-9DB4-4FFB-B9CC-07E812699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5590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109220"/>
            <a:ext cx="2256235" cy="464820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109221"/>
            <a:ext cx="3833813" cy="2341245"/>
          </a:xfrm>
        </p:spPr>
        <p:txBody>
          <a:bodyPr/>
          <a:lstStyle>
            <a:lvl1pPr>
              <a:defRPr sz="2700"/>
            </a:lvl1pPr>
            <a:lvl2pPr>
              <a:defRPr sz="2400"/>
            </a:lvl2pPr>
            <a:lvl3pPr>
              <a:defRPr sz="21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574041"/>
            <a:ext cx="2256235" cy="1876425"/>
          </a:xfrm>
        </p:spPr>
        <p:txBody>
          <a:bodyPr/>
          <a:lstStyle>
            <a:lvl1pPr marL="0" indent="0">
              <a:buNone/>
              <a:defRPr sz="1200"/>
            </a:lvl1pPr>
            <a:lvl2pPr marL="391866" indent="0">
              <a:buNone/>
              <a:defRPr sz="1000"/>
            </a:lvl2pPr>
            <a:lvl3pPr marL="783732" indent="0">
              <a:buNone/>
              <a:defRPr sz="900"/>
            </a:lvl3pPr>
            <a:lvl4pPr marL="1175598" indent="0">
              <a:buNone/>
              <a:defRPr sz="800"/>
            </a:lvl4pPr>
            <a:lvl5pPr marL="1567464" indent="0">
              <a:buNone/>
              <a:defRPr sz="800"/>
            </a:lvl5pPr>
            <a:lvl6pPr marL="1959331" indent="0">
              <a:buNone/>
              <a:defRPr sz="800"/>
            </a:lvl6pPr>
            <a:lvl7pPr marL="2351197" indent="0">
              <a:buNone/>
              <a:defRPr sz="800"/>
            </a:lvl7pPr>
            <a:lvl8pPr marL="2743063" indent="0">
              <a:buNone/>
              <a:defRPr sz="800"/>
            </a:lvl8pPr>
            <a:lvl9pPr marL="3134929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53E27-522A-4E14-B92D-0A123D46A6FB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3E094-9DB4-4FFB-B9CC-07E812699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21510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1920241"/>
            <a:ext cx="4114800" cy="226695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245110"/>
            <a:ext cx="4114800" cy="1645920"/>
          </a:xfrm>
        </p:spPr>
        <p:txBody>
          <a:bodyPr/>
          <a:lstStyle>
            <a:lvl1pPr marL="0" indent="0">
              <a:buNone/>
              <a:defRPr sz="2700"/>
            </a:lvl1pPr>
            <a:lvl2pPr marL="391866" indent="0">
              <a:buNone/>
              <a:defRPr sz="2400"/>
            </a:lvl2pPr>
            <a:lvl3pPr marL="783732" indent="0">
              <a:buNone/>
              <a:defRPr sz="2100"/>
            </a:lvl3pPr>
            <a:lvl4pPr marL="1175598" indent="0">
              <a:buNone/>
              <a:defRPr sz="1700"/>
            </a:lvl4pPr>
            <a:lvl5pPr marL="1567464" indent="0">
              <a:buNone/>
              <a:defRPr sz="1700"/>
            </a:lvl5pPr>
            <a:lvl6pPr marL="1959331" indent="0">
              <a:buNone/>
              <a:defRPr sz="1700"/>
            </a:lvl6pPr>
            <a:lvl7pPr marL="2351197" indent="0">
              <a:buNone/>
              <a:defRPr sz="1700"/>
            </a:lvl7pPr>
            <a:lvl8pPr marL="2743063" indent="0">
              <a:buNone/>
              <a:defRPr sz="1700"/>
            </a:lvl8pPr>
            <a:lvl9pPr marL="3134929" indent="0">
              <a:buNone/>
              <a:defRPr sz="17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2146936"/>
            <a:ext cx="4114800" cy="321945"/>
          </a:xfrm>
        </p:spPr>
        <p:txBody>
          <a:bodyPr/>
          <a:lstStyle>
            <a:lvl1pPr marL="0" indent="0">
              <a:buNone/>
              <a:defRPr sz="1200"/>
            </a:lvl1pPr>
            <a:lvl2pPr marL="391866" indent="0">
              <a:buNone/>
              <a:defRPr sz="1000"/>
            </a:lvl2pPr>
            <a:lvl3pPr marL="783732" indent="0">
              <a:buNone/>
              <a:defRPr sz="900"/>
            </a:lvl3pPr>
            <a:lvl4pPr marL="1175598" indent="0">
              <a:buNone/>
              <a:defRPr sz="800"/>
            </a:lvl4pPr>
            <a:lvl5pPr marL="1567464" indent="0">
              <a:buNone/>
              <a:defRPr sz="800"/>
            </a:lvl5pPr>
            <a:lvl6pPr marL="1959331" indent="0">
              <a:buNone/>
              <a:defRPr sz="800"/>
            </a:lvl6pPr>
            <a:lvl7pPr marL="2351197" indent="0">
              <a:buNone/>
              <a:defRPr sz="800"/>
            </a:lvl7pPr>
            <a:lvl8pPr marL="2743063" indent="0">
              <a:buNone/>
              <a:defRPr sz="800"/>
            </a:lvl8pPr>
            <a:lvl9pPr marL="3134929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653E27-522A-4E14-B92D-0A123D46A6FB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3E094-9DB4-4FFB-B9CC-07E812699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9965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109856"/>
            <a:ext cx="6172200" cy="457200"/>
          </a:xfrm>
          <a:prstGeom prst="rect">
            <a:avLst/>
          </a:prstGeom>
        </p:spPr>
        <p:txBody>
          <a:bodyPr vert="horz" lIns="78373" tIns="39187" rIns="78373" bIns="39187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640082"/>
            <a:ext cx="6172200" cy="1810385"/>
          </a:xfrm>
          <a:prstGeom prst="rect">
            <a:avLst/>
          </a:prstGeom>
        </p:spPr>
        <p:txBody>
          <a:bodyPr vert="horz" lIns="78373" tIns="39187" rIns="78373" bIns="39187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2542541"/>
            <a:ext cx="1600200" cy="146050"/>
          </a:xfrm>
          <a:prstGeom prst="rect">
            <a:avLst/>
          </a:prstGeom>
        </p:spPr>
        <p:txBody>
          <a:bodyPr vert="horz" lIns="78373" tIns="39187" rIns="78373" bIns="39187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653E27-522A-4E14-B92D-0A123D46A6FB}" type="datetimeFigureOut">
              <a:rPr lang="en-GB" smtClean="0"/>
              <a:t>07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2542541"/>
            <a:ext cx="2171700" cy="146050"/>
          </a:xfrm>
          <a:prstGeom prst="rect">
            <a:avLst/>
          </a:prstGeom>
        </p:spPr>
        <p:txBody>
          <a:bodyPr vert="horz" lIns="78373" tIns="39187" rIns="78373" bIns="39187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2542541"/>
            <a:ext cx="1600200" cy="146050"/>
          </a:xfrm>
          <a:prstGeom prst="rect">
            <a:avLst/>
          </a:prstGeom>
        </p:spPr>
        <p:txBody>
          <a:bodyPr vert="horz" lIns="78373" tIns="39187" rIns="78373" bIns="39187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93E094-9DB4-4FFB-B9CC-07E812699C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80498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83732" rtl="0" eaLnBrk="1" latinLnBrk="0" hangingPunct="1">
        <a:spcBef>
          <a:spcPct val="0"/>
        </a:spcBef>
        <a:buNone/>
        <a:defRPr sz="3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3900" indent="-293900" algn="l" defTabSz="783732" rtl="0" eaLnBrk="1" latinLnBrk="0" hangingPunct="1">
        <a:spcBef>
          <a:spcPct val="2000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36782" indent="-244916" algn="l" defTabSz="783732" rtl="0" eaLnBrk="1" latinLnBrk="0" hangingPunct="1">
        <a:spcBef>
          <a:spcPct val="20000"/>
        </a:spcBef>
        <a:buFont typeface="Arial" panose="020B0604020202020204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979665" indent="-195933" algn="l" defTabSz="783732" rtl="0" eaLnBrk="1" latinLnBrk="0" hangingPunct="1">
        <a:spcBef>
          <a:spcPct val="2000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31" indent="-195933" algn="l" defTabSz="783732" rtl="0" eaLnBrk="1" latinLnBrk="0" hangingPunct="1">
        <a:spcBef>
          <a:spcPct val="20000"/>
        </a:spcBef>
        <a:buFont typeface="Arial" panose="020B0604020202020204" pitchFamily="34" charset="0"/>
        <a:buChar char="–"/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763398" indent="-195933" algn="l" defTabSz="783732" rtl="0" eaLnBrk="1" latinLnBrk="0" hangingPunct="1">
        <a:spcBef>
          <a:spcPct val="20000"/>
        </a:spcBef>
        <a:buFont typeface="Arial" panose="020B0604020202020204" pitchFamily="34" charset="0"/>
        <a:buChar char="»"/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155264" indent="-195933" algn="l" defTabSz="783732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547130" indent="-195933" algn="l" defTabSz="783732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2938996" indent="-195933" algn="l" defTabSz="783732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330862" indent="-195933" algn="l" defTabSz="783732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837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1pPr>
      <a:lvl2pPr marL="391866" algn="l" defTabSz="7837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2pPr>
      <a:lvl3pPr marL="783732" algn="l" defTabSz="7837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175598" algn="l" defTabSz="7837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67464" algn="l" defTabSz="7837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959331" algn="l" defTabSz="7837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351197" algn="l" defTabSz="7837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743063" algn="l" defTabSz="7837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3134929" algn="l" defTabSz="783732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 descr="C:\Users\dhanapala\Documents\PROJECT FILES\MANUCRIPT 2015 IN PROGRESS\CAROTENOID PAPER 2014\Old Files\Structure\332 GENO 100000\K=8\Q SIN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4800" y="222870"/>
            <a:ext cx="6447622" cy="16878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5" name="TextBox 24"/>
          <p:cNvSpPr txBox="1"/>
          <p:nvPr/>
        </p:nvSpPr>
        <p:spPr>
          <a:xfrm rot="16200000">
            <a:off x="811198" y="674157"/>
            <a:ext cx="356018" cy="215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1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5958377" y="750358"/>
            <a:ext cx="356018" cy="215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8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>
            <a:off x="1457627" y="700684"/>
            <a:ext cx="356018" cy="215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2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 rot="16200000">
            <a:off x="2197878" y="700685"/>
            <a:ext cx="356018" cy="215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3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 rot="16200000">
            <a:off x="2967472" y="700686"/>
            <a:ext cx="356018" cy="215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4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6200000">
            <a:off x="4470280" y="727214"/>
            <a:ext cx="356018" cy="215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5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 rot="16200000">
            <a:off x="4733228" y="727003"/>
            <a:ext cx="356018" cy="215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6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 rot="16200000">
            <a:off x="5110340" y="727214"/>
            <a:ext cx="356018" cy="21544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7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218359" y="1880160"/>
            <a:ext cx="63246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3 Fig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del-based population structure of 332 soybean genotypes (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= 8). The y-axis is the subgroup membership, and the x-axis is the individual genotypes in each sub population (G1–G8). All 31,253 markers with MAF ≥5 % was used for analysi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01732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7</Words>
  <Application>Microsoft Office PowerPoint</Application>
  <PresentationFormat>Custom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napal, Arun P.</dc:creator>
  <cp:lastModifiedBy>Dhanapal, Arun P.</cp:lastModifiedBy>
  <cp:revision>1</cp:revision>
  <dcterms:created xsi:type="dcterms:W3CDTF">2015-08-07T21:49:27Z</dcterms:created>
  <dcterms:modified xsi:type="dcterms:W3CDTF">2015-08-07T21:51:09Z</dcterms:modified>
</cp:coreProperties>
</file>